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43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FEB75F95-89D1-419B-B2FE-405013C70E70}"/>
    <pc:docChg chg="delSld">
      <pc:chgData name="Norgard,Dr.,Bobby (DR CI+IM) BIP-US-R" userId="8fb42a27-e12b-430d-ab3b-20c232fde4c7" providerId="ADAL" clId="{FEB75F95-89D1-419B-B2FE-405013C70E70}" dt="2024-05-02T15:22:00.593" v="1" actId="47"/>
      <pc:docMkLst>
        <pc:docMk/>
      </pc:docMkLst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FEB75F95-89D1-419B-B2FE-405013C70E70}" dt="2024-05-02T15:21:59.187" v="0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FEB75F95-89D1-419B-B2FE-405013C70E70}" dt="2024-05-02T15:22:00.593" v="1" actId="47"/>
        <pc:sldMkLst>
          <pc:docMk/>
          <pc:sldMk cId="2257143359" sldId="214737474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11886C9-9955-EA77-B912-ADC8BE9D8514}"/>
              </a:ext>
            </a:extLst>
          </p:cNvPr>
          <p:cNvSpPr txBox="1"/>
          <p:nvPr/>
        </p:nvSpPr>
        <p:spPr>
          <a:xfrm>
            <a:off x="378931" y="7831233"/>
            <a:ext cx="609692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raphical abstract outlining the tumor microenvironment changes observed after SOS1i+MEKi with an increase in inflammatory CAFs and increased interactions in macrophages. This results in creation of a highly immunosuppressive microenvironment characterized by M2 macrophage polarization and immature dendritic cells. By applying an immunotherapy regimen of aCTLA4+aPD-1+aCD40, we restore suppressive myeloid cells, reduce tumor burden, and create durable memory responses. </a:t>
            </a:r>
          </a:p>
        </p:txBody>
      </p:sp>
      <p:pic>
        <p:nvPicPr>
          <p:cNvPr id="3" name="Picture 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6892BB61-4EC9-B0D9-E8A9-034FAD5452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71700"/>
            <a:ext cx="6858000" cy="4800600"/>
          </a:xfrm>
          <a:prstGeom prst="rect">
            <a:avLst/>
          </a:prstGeom>
        </p:spPr>
      </p:pic>
      <p:sp>
        <p:nvSpPr>
          <p:cNvPr id="6" name="Title 2">
            <a:extLst>
              <a:ext uri="{FF2B5EF4-FFF2-40B4-BE49-F238E27FC236}">
                <a16:creationId xmlns:a16="http://schemas.microsoft.com/office/drawing/2014/main" id="{02458DD2-5BB3-8F80-A449-7E72EAAC53D9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</p:spTree>
    <p:extLst>
      <p:ext uri="{BB962C8B-B14F-4D97-AF65-F5344CB8AC3E}">
        <p14:creationId xmlns:p14="http://schemas.microsoft.com/office/powerpoint/2010/main" val="1015601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</TotalTime>
  <Words>78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2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